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  <p:sldId id="258" r:id="rId7"/>
  </p:sldIdLst>
  <p:sldSz cy="12192000" cx="6858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8" roundtripDataSignature="AMtx7miaKa3GwblVscCIIEvxM3xp081p7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29845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29845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29845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29845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29845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29845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29845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29845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2a29597cd4e_0_28:notes"/>
          <p:cNvSpPr/>
          <p:nvPr>
            <p:ph idx="2" type="sldImg"/>
          </p:nvPr>
        </p:nvSpPr>
        <p:spPr>
          <a:xfrm>
            <a:off x="2463800" y="685800"/>
            <a:ext cx="19304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82" name="Google Shape;82;g2a29597cd4e_0_2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3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  <p:sp>
        <p:nvSpPr>
          <p:cNvPr id="95" name="Google Shape;95;p2:notes"/>
          <p:cNvSpPr/>
          <p:nvPr>
            <p:ph idx="2" type="sldImg"/>
          </p:nvPr>
        </p:nvSpPr>
        <p:spPr>
          <a:xfrm>
            <a:off x="2463800" y="685800"/>
            <a:ext cx="19304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9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1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1" name="Google Shape;101;p1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titolo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/>
          <p:nvPr>
            <p:ph type="ctrTitle"/>
          </p:nvPr>
        </p:nvSpPr>
        <p:spPr>
          <a:xfrm>
            <a:off x="514350" y="1995312"/>
            <a:ext cx="5829300" cy="424462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4"/>
          <p:cNvSpPr txBox="1"/>
          <p:nvPr>
            <p:ph idx="1" type="subTitle"/>
          </p:nvPr>
        </p:nvSpPr>
        <p:spPr>
          <a:xfrm>
            <a:off x="857250" y="6403623"/>
            <a:ext cx="5143500" cy="29435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/>
        </p:txBody>
      </p:sp>
      <p:sp>
        <p:nvSpPr>
          <p:cNvPr id="14" name="Google Shape;14;p4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" name="Google Shape;15;p4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" name="Google Shape;16;p4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olo e testo verticale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/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3"/>
          <p:cNvSpPr txBox="1"/>
          <p:nvPr>
            <p:ph idx="1" type="body"/>
          </p:nvPr>
        </p:nvSpPr>
        <p:spPr>
          <a:xfrm rot="5400000">
            <a:off x="-438856" y="4155899"/>
            <a:ext cx="7735712" cy="59150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3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3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3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1_Titolo e testo verticale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/>
          <p:nvPr>
            <p:ph type="title"/>
          </p:nvPr>
        </p:nvSpPr>
        <p:spPr>
          <a:xfrm rot="5400000">
            <a:off x="481057" y="5075811"/>
            <a:ext cx="10332156" cy="14787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4"/>
          <p:cNvSpPr txBox="1"/>
          <p:nvPr>
            <p:ph idx="1" type="body"/>
          </p:nvPr>
        </p:nvSpPr>
        <p:spPr>
          <a:xfrm rot="5400000">
            <a:off x="-2519318" y="3639917"/>
            <a:ext cx="10332156" cy="435054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4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4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4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olo e contenuto" type="obj">
  <p:cSld name="OBJECT">
    <p:spTree>
      <p:nvGrpSpPr>
        <p:cNvPr id="17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/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5"/>
          <p:cNvSpPr txBox="1"/>
          <p:nvPr>
            <p:ph idx="1" type="body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0" name="Google Shape;20;p5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5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ntestazione sezione" type="secHead">
  <p:cSld name="SECTION_HEADER">
    <p:spTree>
      <p:nvGrpSpPr>
        <p:cNvPr id="23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/>
          <p:nvPr>
            <p:ph type="title"/>
          </p:nvPr>
        </p:nvSpPr>
        <p:spPr>
          <a:xfrm>
            <a:off x="467916" y="3039537"/>
            <a:ext cx="5915025" cy="507153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6"/>
          <p:cNvSpPr txBox="1"/>
          <p:nvPr>
            <p:ph idx="1" type="body"/>
          </p:nvPr>
        </p:nvSpPr>
        <p:spPr>
          <a:xfrm>
            <a:off x="467916" y="8159048"/>
            <a:ext cx="5915025" cy="266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26" name="Google Shape;26;p6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6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ue contenuti" type="twoObj">
  <p:cSld name="TWO_OBJECTS">
    <p:spTree>
      <p:nvGrpSpPr>
        <p:cNvPr id="29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/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7"/>
          <p:cNvSpPr txBox="1"/>
          <p:nvPr>
            <p:ph idx="1" type="body"/>
          </p:nvPr>
        </p:nvSpPr>
        <p:spPr>
          <a:xfrm>
            <a:off x="471488" y="3245556"/>
            <a:ext cx="2914650" cy="7735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2" name="Google Shape;32;p7"/>
          <p:cNvSpPr txBox="1"/>
          <p:nvPr>
            <p:ph idx="2" type="body"/>
          </p:nvPr>
        </p:nvSpPr>
        <p:spPr>
          <a:xfrm>
            <a:off x="3471863" y="3245556"/>
            <a:ext cx="2914650" cy="7735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3" name="Google Shape;33;p7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7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fronto" type="twoTxTwoObj">
  <p:cSld name="TWO_OBJECTS_WITH_TEXT">
    <p:spTree>
      <p:nvGrpSpPr>
        <p:cNvPr id="36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/>
          <p:nvPr>
            <p:ph type="title"/>
          </p:nvPr>
        </p:nvSpPr>
        <p:spPr>
          <a:xfrm>
            <a:off x="472381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8"/>
          <p:cNvSpPr txBox="1"/>
          <p:nvPr>
            <p:ph idx="1" type="body"/>
          </p:nvPr>
        </p:nvSpPr>
        <p:spPr>
          <a:xfrm>
            <a:off x="472381" y="2988734"/>
            <a:ext cx="2901255" cy="146473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b="1" sz="150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b="1" sz="135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9pPr>
          </a:lstStyle>
          <a:p/>
        </p:txBody>
      </p:sp>
      <p:sp>
        <p:nvSpPr>
          <p:cNvPr id="39" name="Google Shape;39;p8"/>
          <p:cNvSpPr txBox="1"/>
          <p:nvPr>
            <p:ph idx="2" type="body"/>
          </p:nvPr>
        </p:nvSpPr>
        <p:spPr>
          <a:xfrm>
            <a:off x="472381" y="4453467"/>
            <a:ext cx="2901255" cy="655037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0" name="Google Shape;40;p8"/>
          <p:cNvSpPr txBox="1"/>
          <p:nvPr>
            <p:ph idx="3" type="body"/>
          </p:nvPr>
        </p:nvSpPr>
        <p:spPr>
          <a:xfrm>
            <a:off x="3471863" y="2988734"/>
            <a:ext cx="2915543" cy="146473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b="1" sz="150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b="1" sz="135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9pPr>
          </a:lstStyle>
          <a:p/>
        </p:txBody>
      </p:sp>
      <p:sp>
        <p:nvSpPr>
          <p:cNvPr id="41" name="Google Shape;41;p8"/>
          <p:cNvSpPr txBox="1"/>
          <p:nvPr>
            <p:ph idx="4" type="body"/>
          </p:nvPr>
        </p:nvSpPr>
        <p:spPr>
          <a:xfrm>
            <a:off x="3471863" y="4453467"/>
            <a:ext cx="2915543" cy="655037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8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titolo" type="titleOnly">
  <p:cSld name="TITLE_ONLY">
    <p:spTree>
      <p:nvGrpSpPr>
        <p:cNvPr id="45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/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9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9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9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uota" type="blank">
  <p:cSld name="BLANK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0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0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uto con didascalia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/>
          <p:nvPr>
            <p:ph type="title"/>
          </p:nvPr>
        </p:nvSpPr>
        <p:spPr>
          <a:xfrm>
            <a:off x="472381" y="812800"/>
            <a:ext cx="2211884" cy="28448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1"/>
          <p:cNvSpPr txBox="1"/>
          <p:nvPr>
            <p:ph idx="1" type="body"/>
          </p:nvPr>
        </p:nvSpPr>
        <p:spPr>
          <a:xfrm>
            <a:off x="2915543" y="1755425"/>
            <a:ext cx="3471863" cy="866422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6195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2385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indent="-32385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indent="-32385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indent="-32385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indent="-32385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indent="-32385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/>
        </p:txBody>
      </p:sp>
      <p:sp>
        <p:nvSpPr>
          <p:cNvPr id="57" name="Google Shape;57;p11"/>
          <p:cNvSpPr txBox="1"/>
          <p:nvPr>
            <p:ph idx="2" type="body"/>
          </p:nvPr>
        </p:nvSpPr>
        <p:spPr>
          <a:xfrm>
            <a:off x="472381" y="3657600"/>
            <a:ext cx="2211884" cy="677615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/>
        </p:txBody>
      </p:sp>
      <p:sp>
        <p:nvSpPr>
          <p:cNvPr id="58" name="Google Shape;58;p11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1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1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magine con didascalia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/>
          <p:nvPr>
            <p:ph type="title"/>
          </p:nvPr>
        </p:nvSpPr>
        <p:spPr>
          <a:xfrm>
            <a:off x="472381" y="812800"/>
            <a:ext cx="2211884" cy="28448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2"/>
          <p:cNvSpPr/>
          <p:nvPr>
            <p:ph idx="2" type="pic"/>
          </p:nvPr>
        </p:nvSpPr>
        <p:spPr>
          <a:xfrm>
            <a:off x="2915543" y="1755425"/>
            <a:ext cx="3471863" cy="8664222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/>
          <p:nvPr>
            <p:ph idx="1" type="body"/>
          </p:nvPr>
        </p:nvSpPr>
        <p:spPr>
          <a:xfrm>
            <a:off x="472381" y="3657600"/>
            <a:ext cx="2211884" cy="677615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/>
        </p:txBody>
      </p:sp>
      <p:sp>
        <p:nvSpPr>
          <p:cNvPr id="65" name="Google Shape;65;p12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2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2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/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b="0" i="0" sz="33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7" name="Google Shape;7;p3"/>
          <p:cNvSpPr txBox="1"/>
          <p:nvPr>
            <p:ph idx="1" type="body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61950" lvl="0" marL="457200" marR="0" rtl="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b="0" i="0" sz="2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42900" lvl="1" marL="9144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23850" lvl="2" marL="13716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b="0" i="0" sz="15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14325" lvl="3" marL="18288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14325" lvl="4" marL="22860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14325" lvl="5" marL="27432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14325" lvl="6" marL="32004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14325" lvl="7" marL="36576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14325" lvl="8" marL="41148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3"/>
          <p:cNvSpPr txBox="1"/>
          <p:nvPr>
            <p:ph idx="10" type="dt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3"/>
          <p:cNvSpPr txBox="1"/>
          <p:nvPr>
            <p:ph idx="11" type="ftr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3"/>
          <p:cNvSpPr txBox="1"/>
          <p:nvPr>
            <p:ph idx="12" type="sldNum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4.png"/><Relationship Id="rId4" Type="http://schemas.openxmlformats.org/officeDocument/2006/relationships/image" Target="../media/image2.png"/><Relationship Id="rId5" Type="http://schemas.openxmlformats.org/officeDocument/2006/relationships/image" Target="../media/image1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5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g2a29597cd4e_0_28"/>
          <p:cNvSpPr txBox="1"/>
          <p:nvPr/>
        </p:nvSpPr>
        <p:spPr>
          <a:xfrm>
            <a:off x="433800" y="9441355"/>
            <a:ext cx="5990400" cy="792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egend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SW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men who have sex with wome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SM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women who have sex with me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MI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body mass index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IDS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cquired immunodeficiency syndrom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RT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ntiretroviral therapy; 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5; *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1; **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01.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" name="Google Shape;85;g2a29597cd4e_0_28"/>
          <p:cNvSpPr txBox="1"/>
          <p:nvPr/>
        </p:nvSpPr>
        <p:spPr>
          <a:xfrm>
            <a:off x="433800" y="6673600"/>
            <a:ext cx="5990400" cy="792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egend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SW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men who have sex with wome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SM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women who have sex with me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MI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body mass index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IDS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cquired immunodeficiency syndrom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RT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ntiretroviral therapy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STI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integrase strand-transfer inhibitor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NRTI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non-nucleoside reverse transcriptase inhibitor; 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5; *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1; **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01.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" name="Google Shape;86;g2a29597cd4e_0_28"/>
          <p:cNvSpPr txBox="1"/>
          <p:nvPr/>
        </p:nvSpPr>
        <p:spPr>
          <a:xfrm>
            <a:off x="388348" y="2929942"/>
            <a:ext cx="5993375" cy="792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1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egend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SW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men who have sex with wome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SM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women who have sex with me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IDS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cquired immunodeficiency syndrom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RT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ntiretroviral therapy; 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5; *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1; ***: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≤0.001.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7" name="Google Shape;87;g2a29597cd4e_0_2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32325" y="4616260"/>
            <a:ext cx="5993350" cy="2067033"/>
          </a:xfrm>
          <a:prstGeom prst="rect">
            <a:avLst/>
          </a:prstGeom>
          <a:noFill/>
          <a:ln>
            <a:noFill/>
          </a:ln>
        </p:spPr>
      </p:pic>
      <p:pic>
        <p:nvPicPr>
          <p:cNvPr id="88" name="Google Shape;88;g2a29597cd4e_0_2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2325" y="8359918"/>
            <a:ext cx="5993350" cy="1081437"/>
          </a:xfrm>
          <a:prstGeom prst="rect">
            <a:avLst/>
          </a:prstGeom>
          <a:noFill/>
          <a:ln>
            <a:noFill/>
          </a:ln>
        </p:spPr>
      </p:pic>
      <p:pic>
        <p:nvPicPr>
          <p:cNvPr id="89" name="Google Shape;89;g2a29597cd4e_0_28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432328" y="1362710"/>
            <a:ext cx="5993345" cy="1576925"/>
          </a:xfrm>
          <a:prstGeom prst="rect">
            <a:avLst/>
          </a:prstGeom>
          <a:noFill/>
          <a:ln>
            <a:noFill/>
          </a:ln>
        </p:spPr>
      </p:pic>
      <p:sp>
        <p:nvSpPr>
          <p:cNvPr id="90" name="Google Shape;90;g2a29597cd4e_0_28"/>
          <p:cNvSpPr txBox="1"/>
          <p:nvPr/>
        </p:nvSpPr>
        <p:spPr>
          <a:xfrm>
            <a:off x="388348" y="4274297"/>
            <a:ext cx="5787000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it-IT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dditional file 1: Table S2. Summary of Backward model regression analysis</a:t>
            </a:r>
            <a:r>
              <a:rPr b="0" i="0" lang="it-IT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/>
          </a:p>
        </p:txBody>
      </p:sp>
      <p:sp>
        <p:nvSpPr>
          <p:cNvPr id="91" name="Google Shape;91;g2a29597cd4e_0_28"/>
          <p:cNvSpPr txBox="1"/>
          <p:nvPr/>
        </p:nvSpPr>
        <p:spPr>
          <a:xfrm>
            <a:off x="388348" y="1020747"/>
            <a:ext cx="5732552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it-IT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dditional file 1: Table S1. Summary of Forward model regression analysis</a:t>
            </a:r>
            <a:endParaRPr b="0" i="0" sz="12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g2a29597cd4e_0_28"/>
          <p:cNvSpPr txBox="1"/>
          <p:nvPr/>
        </p:nvSpPr>
        <p:spPr>
          <a:xfrm>
            <a:off x="388348" y="8082919"/>
            <a:ext cx="5471727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it-IT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dditional file 1: Table S3. Summary of Multi-Model regression analysis</a:t>
            </a:r>
            <a:r>
              <a:rPr b="0" i="0" lang="it-IT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6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Google Shape;97;p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32367" y="889500"/>
            <a:ext cx="4593266" cy="4107801"/>
          </a:xfrm>
          <a:prstGeom prst="rect">
            <a:avLst/>
          </a:prstGeom>
          <a:noFill/>
          <a:ln>
            <a:noFill/>
          </a:ln>
        </p:spPr>
      </p:pic>
      <p:sp>
        <p:nvSpPr>
          <p:cNvPr id="98" name="Google Shape;98;p2"/>
          <p:cNvSpPr txBox="1"/>
          <p:nvPr/>
        </p:nvSpPr>
        <p:spPr>
          <a:xfrm>
            <a:off x="349079" y="5404843"/>
            <a:ext cx="6159843" cy="691157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dditional file 1: Figure S</a:t>
            </a:r>
            <a:r>
              <a:rPr b="1" lang="it-IT" sz="1000">
                <a:solidFill>
                  <a:schemeClr val="dk1"/>
                </a:solidFill>
              </a:rPr>
              <a:t>1</a:t>
            </a:r>
            <a:r>
              <a:rPr b="1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Tree Regression model importance plot.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Variables selected as most important and used to build the final optimal tree of the model. Variable importances, calculated by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part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package, are reported on both x-axis and sphere radious. A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T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ntiretroviral therapy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MI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body mass index.</a:t>
            </a: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2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p15"/>
          <p:cNvSpPr txBox="1"/>
          <p:nvPr/>
        </p:nvSpPr>
        <p:spPr>
          <a:xfrm>
            <a:off x="304650" y="5830438"/>
            <a:ext cx="6248700" cy="1622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1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dditional file 1: Figure S</a:t>
            </a:r>
            <a:r>
              <a:rPr b="1" lang="it-IT" sz="1000">
                <a:solidFill>
                  <a:schemeClr val="dk1"/>
                </a:solidFill>
              </a:rPr>
              <a:t>2</a:t>
            </a:r>
            <a:r>
              <a:rPr b="1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Spearman correlation analysis.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rrelation analysis performed between the top 5 important variables selected from the Random Forest model (y-axis) and anti-S IgG (binding antibody units per milliliter (BAU/mL)) at each time point (x-axis). R</a:t>
            </a:r>
            <a:r>
              <a:rPr b="0" baseline="3000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values are expressed as colour gradient ranging from violet to yellow. Numerical P-values of each pairwise comparison are reported within each box.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MI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body mass index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A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not applicabl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1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1 month after the first dose, coinciding with the day of the second dos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2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1 month after the second dos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3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6 months after the second dose, coinciding with the third dose administratio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4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1 month after the third dos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5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6 months after the third dos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6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12 months after the third dose, coinciding with the fourth dose administration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7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1 month after the fourth dose; </a:t>
            </a:r>
            <a:r>
              <a:rPr b="0" i="1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8</a:t>
            </a:r>
            <a:r>
              <a:rPr b="0" i="0" lang="it-IT" sz="1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6 months after the fourth dose.</a:t>
            </a:r>
            <a:endParaRPr b="0" i="0" sz="8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4" name="Google Shape;104;p1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27550" y="1123563"/>
            <a:ext cx="5802900" cy="459585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i Office">
  <a:themeElements>
    <a:clrScheme name="Tema di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11-28T14:14:26Z</dcterms:created>
  <dc:creator>Giorgio Montesi</dc:creator>
</cp:coreProperties>
</file>